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  <p:sldId id="259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754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31CF227-7DDC-E9E9-729D-DF92CC890A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6E82250-2514-7EE1-6824-B9D3F9F3B5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DF30825-1A18-A852-DADC-1072EA1DA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9B1F3E8-E255-962B-A7E1-9531D3D4B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2F8DA41-A33B-39D8-0AA6-239BDA1D0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85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01255B-E0CB-4B99-369D-0ECD47BA0E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6292968-78F9-4546-3CC9-A3EF5C4B6F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9C25E6E-71EE-B8FD-F7AA-1C81AA78B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E436288-3917-BB4A-6B88-6C7194772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F2954FB-B872-4F7B-6FE9-C524BD54B9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7065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D44EBE02-3CB5-06B4-4E34-FF8697572A2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4572CB7-0492-FC56-E9DD-E3DC93BD5A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0ABF25E-A326-9FC4-C792-58B79A2AC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8D2A976-8D33-0BFE-19E8-F45C89745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FB4E35-B34A-5864-F02B-8F9FF7806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9550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31AD867-9486-19FB-F6EA-248C29D49C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BF4B594-26B0-CE02-E62F-4085DF2797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54CBD55-D168-B711-5D19-AF1CAB965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77C1E3C-151A-7A1D-09FD-EEB528C56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7B98FE-F880-3F69-0BF7-B6643EAFD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5707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BF6BB86-EB3E-D17E-8A5E-81AED37D8D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D5A454F-71F1-1AAC-E68D-28CD98E53F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B9415A-65BE-BCDF-41A9-54954663C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065190A-A1CC-9ED3-E7CA-D66F10582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4F1EFD3-BF54-F033-988F-BD9E1F615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0144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7BAE26-9C96-A1E5-99F8-2B424311E8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B365DE1-570D-B53F-2C13-C29795317A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19DBC05-7405-935D-C138-7CA27EA5F8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2D25681-617E-D62D-AEF3-65183FD9B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DD02125-3F37-C7CC-A6F8-CAE305E9C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5CE6D92-C05E-A6D2-A2DF-EA4991C02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5734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FA9F15-1C98-867B-455E-F1BB6A7FAA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85FA4DB-5F7B-8177-B2D2-E4B3FD71AA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0EABF9F-7591-1C6B-475C-0EE77DF17A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9994C83-89BC-023D-D24C-664D91494A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FBD19D0-2568-52BB-F2CC-B6D74385BA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F8D7612-631E-D627-DC3D-0AAC252D3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79B90B7-14DF-5B73-FCC0-B09A016881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460C7ED-3622-1700-5420-C6D0D59DD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693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38B73E8-E8BE-0F33-6993-E3C5AABFC9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DEA4D64-B6EA-0954-21D0-071D76167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E7DDF5EF-46B4-C04F-B4B0-C903C049A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F4290E76-B5A2-66EC-CBA5-02EF7DE66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6806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7D9CBAF-2095-A29C-19F7-AEBB54678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62B080C7-1436-AC4D-D0C6-9D89B5F64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2FCCD2C8-38DE-957B-8144-666E27025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7903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3F1321D-E196-401F-C333-8914476AB1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4049566-87F3-107C-BFDC-E9FA5CA6AB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32615C1-1297-5FBC-0188-AE8AB7BDCE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68C9A03-35D1-58FE-285F-928408E7D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0962001-B7EE-0F21-D477-2CE6DC1BD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1D50AB-D662-BCAE-524D-7E73BBE0B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5528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331ED2-37DB-C602-4314-3148181B2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528F54A-B9E2-EFB1-53DF-D74CFB1E3D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8A9AE09-0E34-4838-DEDB-76D419FA68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0E8F789-FF60-004A-19EC-C7468C639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D8C79ED-1CDB-F7A5-C02F-54F1FAD8F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1C7E25A-4B49-988D-045D-C35743A1D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7073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1FE0DFA-6F80-2BDC-C822-7984355F0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7CC8A0C-7BE1-313B-E065-B9690BCE0B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4CF4E6B-0CDD-8138-1AE8-10B18D7149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18D072-A8C5-423F-8520-C0CD538FB8FB}" type="datetimeFigureOut">
              <a:rPr lang="ko-KR" altLang="en-US" smtClean="0"/>
              <a:t>2025-08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2E7F1A-52B0-B6DE-0FCE-FC600B8C06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2D03540-43BF-18B2-EEB6-3DF96637AA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EEE1B6-D159-487A-82BF-C43EB24FAB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0083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D046AC-E767-4852-327F-075A80A7F7E5}"/>
              </a:ext>
            </a:extLst>
          </p:cNvPr>
          <p:cNvSpPr txBox="1"/>
          <p:nvPr/>
        </p:nvSpPr>
        <p:spPr>
          <a:xfrm>
            <a:off x="95187" y="84280"/>
            <a:ext cx="3032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data</a:t>
            </a:r>
            <a:endParaRPr lang="ko-KR" alt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06D049-467F-3E87-EEFA-3008F7809B3E}"/>
              </a:ext>
            </a:extLst>
          </p:cNvPr>
          <p:cNvSpPr txBox="1"/>
          <p:nvPr/>
        </p:nvSpPr>
        <p:spPr>
          <a:xfrm>
            <a:off x="642928" y="905155"/>
            <a:ext cx="11095347" cy="8809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Betulinic Acid-Enriched </a:t>
            </a:r>
            <a:r>
              <a:rPr lang="en-US" altLang="ko-KR" b="1" i="1" dirty="0" err="1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Dillenia</a:t>
            </a:r>
            <a:r>
              <a:rPr lang="en-US" altLang="ko-KR" b="1" i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indica </a:t>
            </a:r>
            <a:r>
              <a:rPr lang="en-US" altLang="ko-KR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L. Bark Extract Attenuates UVB-Induced Skin Aging via KEAP1-Mediated Antioxidant Pathway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9C9A81-18DA-1DB4-0FFF-63B550D6635D}"/>
              </a:ext>
            </a:extLst>
          </p:cNvPr>
          <p:cNvSpPr txBox="1"/>
          <p:nvPr/>
        </p:nvSpPr>
        <p:spPr>
          <a:xfrm>
            <a:off x="642929" y="2228733"/>
            <a:ext cx="11095347" cy="3494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sv-SE" altLang="ko-KR" sz="14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Bo-Rim Song </a:t>
            </a:r>
            <a:r>
              <a:rPr lang="sv-SE" altLang="ko-KR" sz="1400" b="1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1</a:t>
            </a:r>
            <a:r>
              <a:rPr lang="sv-SE" altLang="ko-KR" sz="14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, Sunghwan Kim </a:t>
            </a:r>
            <a:r>
              <a:rPr lang="sv-SE" altLang="ko-KR" sz="1400" b="1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2,3</a:t>
            </a:r>
            <a:r>
              <a:rPr lang="sv-SE" altLang="ko-KR" sz="14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and Sang-Han Lee </a:t>
            </a:r>
            <a:r>
              <a:rPr lang="sv-SE" altLang="ko-KR" sz="1400" b="1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1,4,*</a:t>
            </a:r>
          </a:p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sz="1200" b="1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1</a:t>
            </a: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Department of Food Science and Biotechnology, Graduate School, Kyungpook National University, Daegu 41566, Korea</a:t>
            </a:r>
          </a:p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sz="1200" b="1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2</a:t>
            </a: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Department of Chemistry, Kyungpook National University, Daegu, 41566, Republic of Korea</a:t>
            </a:r>
          </a:p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sz="1200" b="1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3</a:t>
            </a: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Mass Spectrometry Converging Research Center and Green-Nano Materials Research Center, Daegu, 41566, Republic of Korea</a:t>
            </a:r>
          </a:p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sz="1200" b="1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4</a:t>
            </a: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Inner Beauty/Antiaging Center, Kyungpook National University, Daegu 41566, Korea </a:t>
            </a:r>
          </a:p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sz="1200" b="1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*</a:t>
            </a: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Correspondence: sang@knu.ac.kr (S.-H. Lee)</a:t>
            </a:r>
          </a:p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*Corresponding author at: Lab of Food Enzyme Biotechnology, College of Agriculture and Life Sciences, Kyungpook National University, Daegu 41566, Republic of Korea.</a:t>
            </a:r>
          </a:p>
          <a:p>
            <a:pPr algn="ctr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E-mail address: sang@knu.ac.kr (S.-H. Lee)</a:t>
            </a:r>
          </a:p>
        </p:txBody>
      </p:sp>
    </p:spTree>
    <p:extLst>
      <p:ext uri="{BB962C8B-B14F-4D97-AF65-F5344CB8AC3E}">
        <p14:creationId xmlns:p14="http://schemas.microsoft.com/office/powerpoint/2010/main" val="16690034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371C837-B3FE-49DA-FAF9-C5A7815AA152}"/>
              </a:ext>
            </a:extLst>
          </p:cNvPr>
          <p:cNvSpPr txBox="1"/>
          <p:nvPr/>
        </p:nvSpPr>
        <p:spPr>
          <a:xfrm>
            <a:off x="373001" y="336855"/>
            <a:ext cx="24266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Palatino Linotype" panose="02040502050505030304" pitchFamily="18" charset="0"/>
                <a:cs typeface="Arial" panose="020B0604020202020204" pitchFamily="34" charset="0"/>
              </a:rPr>
              <a:t>Materials and methods</a:t>
            </a:r>
            <a:endParaRPr lang="ko-KR" altLang="en-US" sz="16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6BC372C-E9F2-E0D5-FB8A-DB8613C38D9A}"/>
              </a:ext>
            </a:extLst>
          </p:cNvPr>
          <p:cNvSpPr txBox="1"/>
          <p:nvPr/>
        </p:nvSpPr>
        <p:spPr>
          <a:xfrm>
            <a:off x="373001" y="854806"/>
            <a:ext cx="11127337" cy="12943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Single Factor Experiments</a:t>
            </a:r>
            <a:endParaRPr lang="ko-KR" altLang="ko-KR" sz="1200" dirty="0">
              <a:effectLst/>
              <a:latin typeface="Palatino Linotype" panose="02040502050505030304" pitchFamily="18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altLang="ko-KR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Preliminary single factor experiments were conducted to determine the influence of extraction temperature (20, 40, 50, 60, and 70℃), ethanol concentration (20, 50, 70, and 90%), and extraction time (10, 20, 30, 40, and 50 min) on the yield of total phenolic content (TPC) and total flavonoid content (TFC). A fixed solid-to-liquid ratio of 1:10(g/mL) and ultrasonic power of 35 kHz with a power of 50.</a:t>
            </a:r>
            <a:endParaRPr lang="ko-KR" altLang="ko-KR" sz="1200" dirty="0">
              <a:effectLst/>
              <a:latin typeface="Palatino Linotype" panose="02040502050505030304" pitchFamily="18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4A049105-285E-C02B-6244-FA004BE6A6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001" y="2299799"/>
            <a:ext cx="6033641" cy="430348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697EF82-3974-D230-7AD7-1656C435ADEF}"/>
              </a:ext>
            </a:extLst>
          </p:cNvPr>
          <p:cNvSpPr txBox="1"/>
          <p:nvPr/>
        </p:nvSpPr>
        <p:spPr>
          <a:xfrm>
            <a:off x="6564923" y="4993425"/>
            <a:ext cx="493541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1. Figure 1. Effect of single extraction parameters on total phenolic content (TPC; A-C) and total flavonoid content (TFC; D-F). </a:t>
            </a:r>
            <a:r>
              <a:rPr lang="en-US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A and D represent the influence of extraction temperature (20–70 °C), B and E depict ethanol concentration (20–90%), and C and F show extraction time (10–50 min). Data are presented as mean ± SD (n = 3). Different letters indicate statistically significant differences (</a:t>
            </a:r>
            <a:r>
              <a:rPr lang="en-US" altLang="ko-KR" sz="1200" i="1" dirty="0">
                <a:latin typeface="Palatino Linotype" panose="02040502050505030304" pitchFamily="18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&lt; 0.05) based on Tukey’s multiple comparison test.</a:t>
            </a:r>
            <a:endParaRPr lang="ko-KR" altLang="en-US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67882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1972CB0-66C6-CCBC-F9F7-02F83DFD2F06}"/>
              </a:ext>
            </a:extLst>
          </p:cNvPr>
          <p:cNvSpPr txBox="1"/>
          <p:nvPr/>
        </p:nvSpPr>
        <p:spPr>
          <a:xfrm>
            <a:off x="2560946" y="2265768"/>
            <a:ext cx="71486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Table S1. Binding affinity values (kcal/mol) of triterpenoids (</a:t>
            </a:r>
            <a:r>
              <a:rPr lang="en-US" altLang="ko-KR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betulin</a:t>
            </a:r>
            <a:r>
              <a:rPr lang="en-US" altLang="ko-KR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, </a:t>
            </a:r>
            <a:r>
              <a:rPr lang="en-US" altLang="ko-KR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betulinic</a:t>
            </a:r>
            <a:r>
              <a:rPr lang="en-US" altLang="ko-KR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acid, and </a:t>
            </a:r>
            <a:r>
              <a:rPr lang="en-US" altLang="ko-KR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betulonic</a:t>
            </a:r>
            <a:r>
              <a:rPr lang="en-US" altLang="ko-KR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acid) with the KEAP1 Kelch domain predicted using </a:t>
            </a:r>
            <a:r>
              <a:rPr lang="en-US" altLang="ko-KR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AutoDdock</a:t>
            </a:r>
            <a:r>
              <a:rPr lang="en-US" altLang="ko-KR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and </a:t>
            </a:r>
            <a:r>
              <a:rPr lang="en-US" altLang="ko-KR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MolDock</a:t>
            </a:r>
            <a:r>
              <a:rPr lang="en-US" altLang="ko-KR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docking algorithms. </a:t>
            </a:r>
          </a:p>
          <a:p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B9A9E51A-FA1D-3C44-6AEB-7674267D2A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5379359"/>
              </p:ext>
            </p:extLst>
          </p:nvPr>
        </p:nvGraphicFramePr>
        <p:xfrm>
          <a:off x="2630078" y="2770697"/>
          <a:ext cx="6892563" cy="152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97521">
                  <a:extLst>
                    <a:ext uri="{9D8B030D-6E8A-4147-A177-3AD203B41FA5}">
                      <a16:colId xmlns:a16="http://schemas.microsoft.com/office/drawing/2014/main" val="2958671688"/>
                    </a:ext>
                  </a:extLst>
                </a:gridCol>
                <a:gridCol w="2297521">
                  <a:extLst>
                    <a:ext uri="{9D8B030D-6E8A-4147-A177-3AD203B41FA5}">
                      <a16:colId xmlns:a16="http://schemas.microsoft.com/office/drawing/2014/main" val="1391514971"/>
                    </a:ext>
                  </a:extLst>
                </a:gridCol>
                <a:gridCol w="2297521">
                  <a:extLst>
                    <a:ext uri="{9D8B030D-6E8A-4147-A177-3AD203B41FA5}">
                      <a16:colId xmlns:a16="http://schemas.microsoft.com/office/drawing/2014/main" val="800082751"/>
                    </a:ext>
                  </a:extLst>
                </a:gridCol>
              </a:tblGrid>
              <a:tr h="227499">
                <a:tc>
                  <a:txBody>
                    <a:bodyPr/>
                    <a:lstStyle/>
                    <a:p>
                      <a:pPr latinLnBrk="1"/>
                      <a:endParaRPr lang="ko-KR" altLang="en-US" sz="1400" b="1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err="1">
                          <a:latin typeface="Palatino Linotype" panose="02040502050505030304" pitchFamily="18" charset="0"/>
                        </a:rPr>
                        <a:t>AutoDock</a:t>
                      </a:r>
                      <a:r>
                        <a:rPr lang="en-US" altLang="ko-KR" sz="1400" b="1" dirty="0">
                          <a:latin typeface="Palatino Linotype" panose="02040502050505030304" pitchFamily="18" charset="0"/>
                        </a:rPr>
                        <a:t> (kcal/mol)</a:t>
                      </a:r>
                      <a:endParaRPr lang="ko-KR" altLang="en-US" sz="1400" b="1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err="1">
                          <a:latin typeface="Palatino Linotype" panose="02040502050505030304" pitchFamily="18" charset="0"/>
                        </a:rPr>
                        <a:t>MolDock</a:t>
                      </a:r>
                      <a:r>
                        <a:rPr lang="en-US" altLang="ko-KR" sz="1400" b="1" dirty="0">
                          <a:latin typeface="Palatino Linotype" panose="02040502050505030304" pitchFamily="18" charset="0"/>
                        </a:rPr>
                        <a:t> (kcal/mol)</a:t>
                      </a:r>
                      <a:endParaRPr lang="ko-KR" altLang="en-US" sz="1400" b="1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167601"/>
                  </a:ext>
                </a:extLst>
              </a:tr>
              <a:tr h="22749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Sulforaphane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-4.5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-76.8183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258053858"/>
                  </a:ext>
                </a:extLst>
              </a:tr>
              <a:tr h="22749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err="1">
                          <a:latin typeface="Palatino Linotype" panose="02040502050505030304" pitchFamily="18" charset="0"/>
                        </a:rPr>
                        <a:t>Betulin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-7.8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-144.780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0134933"/>
                  </a:ext>
                </a:extLst>
              </a:tr>
              <a:tr h="22749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Betulinic acid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-8.3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-138.286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0074581"/>
                  </a:ext>
                </a:extLst>
              </a:tr>
              <a:tr h="22749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err="1">
                          <a:latin typeface="Palatino Linotype" panose="02040502050505030304" pitchFamily="18" charset="0"/>
                        </a:rPr>
                        <a:t>Betulonic</a:t>
                      </a:r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 acid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-8.1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latin typeface="Palatino Linotype" panose="02040502050505030304" pitchFamily="18" charset="0"/>
                        </a:rPr>
                        <a:t>-140.201</a:t>
                      </a:r>
                      <a:endParaRPr lang="ko-KR" altLang="en-US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91343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17401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30F8773-00BE-CDDF-0030-E34B8A4DF4FC}"/>
              </a:ext>
            </a:extLst>
          </p:cNvPr>
          <p:cNvSpPr txBox="1"/>
          <p:nvPr/>
        </p:nvSpPr>
        <p:spPr>
          <a:xfrm>
            <a:off x="4442520" y="648299"/>
            <a:ext cx="4428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S2. ANOVA for quadratic model (function: none).</a:t>
            </a:r>
            <a:endParaRPr lang="ko-KR" altLang="en-US" sz="12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2492E02E-3E1B-4BF0-4082-50ABA3E50E3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" b="50690"/>
          <a:stretch>
            <a:fillRect/>
          </a:stretch>
        </p:blipFill>
        <p:spPr>
          <a:xfrm>
            <a:off x="505904" y="1126051"/>
            <a:ext cx="5142019" cy="33196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8F34DD6F-E715-B136-CFB2-F539E5F393A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50155" b="1051"/>
          <a:stretch>
            <a:fillRect/>
          </a:stretch>
        </p:blipFill>
        <p:spPr>
          <a:xfrm>
            <a:off x="6349708" y="1089897"/>
            <a:ext cx="5252819" cy="33558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80B2065-F200-14C4-DDDE-E0A548AC99EE}"/>
              </a:ext>
            </a:extLst>
          </p:cNvPr>
          <p:cNvSpPr txBox="1"/>
          <p:nvPr/>
        </p:nvSpPr>
        <p:spPr>
          <a:xfrm>
            <a:off x="505904" y="4515685"/>
            <a:ext cx="115949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X1: Ethanol concentration (%); X2: time (min); X3: temperature (°C); RC: Regression coefficient; SS: sum of squares; DF: the total degrees of freedom; MS: mean square.</a:t>
            </a:r>
            <a:endParaRPr lang="ko-KR" altLang="en-U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48643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44C45EE3-DE66-1DA9-A5AF-4E192BA9E9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026" y="2340298"/>
            <a:ext cx="5916675" cy="14926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47D26DD-C239-56F8-9CFA-B2001EEFB1F7}"/>
              </a:ext>
            </a:extLst>
          </p:cNvPr>
          <p:cNvSpPr txBox="1"/>
          <p:nvPr/>
        </p:nvSpPr>
        <p:spPr>
          <a:xfrm>
            <a:off x="78726" y="3771389"/>
            <a:ext cx="6017274" cy="6180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GB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</a:t>
            </a:r>
            <a:r>
              <a:rPr lang="en-GB" altLang="ko-KR" sz="1200" baseline="30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GB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: correlation coefficients; RMSE: root mean square error; AAD: absolute average deviation; SEP: standard error of prediction.</a:t>
            </a:r>
            <a:endParaRPr lang="ko-KR" altLang="ko-KR" sz="1200" dirty="0">
              <a:effectLst/>
              <a:latin typeface="Palatino Linotype" panose="0204050205050503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CA4630-C33D-72AE-2878-1CEE25117C78}"/>
              </a:ext>
            </a:extLst>
          </p:cNvPr>
          <p:cNvSpPr txBox="1"/>
          <p:nvPr/>
        </p:nvSpPr>
        <p:spPr>
          <a:xfrm>
            <a:off x="1034563" y="1976226"/>
            <a:ext cx="4910542" cy="341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able S</a:t>
            </a:r>
            <a:r>
              <a:rPr lang="en-GB" altLang="ko-KR" sz="1200" b="1" dirty="0"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3.</a:t>
            </a: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Comparison of the prediction ability of RSM and ANN.</a:t>
            </a:r>
            <a:endParaRPr lang="ko-KR" altLang="ko-KR" sz="1200" b="1" dirty="0">
              <a:effectLst/>
              <a:latin typeface="Palatino Linotype" panose="0204050205050503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0AB8EE2-97F0-90A7-FC38-AE4347AC5B13}"/>
              </a:ext>
            </a:extLst>
          </p:cNvPr>
          <p:cNvSpPr txBox="1"/>
          <p:nvPr/>
        </p:nvSpPr>
        <p:spPr>
          <a:xfrm>
            <a:off x="6405017" y="1713494"/>
            <a:ext cx="5528860" cy="616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2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able S4. Reproducibility and comparative performance of ANN models across multiple random initializations (n = 10 runs).</a:t>
            </a:r>
            <a:endParaRPr lang="ko-KR" altLang="ko-KR" sz="1200" b="1" dirty="0">
              <a:effectLst/>
              <a:latin typeface="Palatino Linotype" panose="0204050205050503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B21D760-FA97-CAA9-56BC-9A0F23A154C2}"/>
              </a:ext>
            </a:extLst>
          </p:cNvPr>
          <p:cNvSpPr txBox="1"/>
          <p:nvPr/>
        </p:nvSpPr>
        <p:spPr>
          <a:xfrm>
            <a:off x="6446278" y="4034789"/>
            <a:ext cx="548759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ean ± SD and range (min–max) of R² and RMSE for TPC and TFC predictions obtained from ten independent trainings with different random weight initializations under identical hyperparameters. Dataset split (train/validation/test = 65/20/15) was fixed across runs to isolate variability from initialization. Paired t-test comparing ANN and RSM prediction errors indicated a statistically significant improvement with ANN for both TPC (</a:t>
            </a:r>
            <a:r>
              <a:rPr lang="en-US" altLang="ko-KR" sz="1200" i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&lt; 0.001) and TFC (</a:t>
            </a:r>
            <a:r>
              <a:rPr lang="en-US" altLang="ko-KR" sz="1200" i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&lt; 0.001).</a:t>
            </a:r>
            <a:endParaRPr lang="ko-KR" altLang="en-US" sz="1200" dirty="0">
              <a:latin typeface="Palatino Linotype" panose="02040502050505030304" pitchFamily="18" charset="0"/>
            </a:endParaRP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FC4FF35C-7C24-685C-EB2B-34729898D1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6278" y="2439347"/>
            <a:ext cx="5456393" cy="14926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4587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1</TotalTime>
  <Words>615</Words>
  <Application>Microsoft Office PowerPoint</Application>
  <PresentationFormat>Widescreen</PresentationFormat>
  <Paragraphs>3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맑은 고딕</vt:lpstr>
      <vt:lpstr>Arial</vt:lpstr>
      <vt:lpstr>Palatino Linotype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송보림</dc:creator>
  <cp:lastModifiedBy>MDPI</cp:lastModifiedBy>
  <cp:revision>19</cp:revision>
  <dcterms:created xsi:type="dcterms:W3CDTF">2025-07-08T01:04:27Z</dcterms:created>
  <dcterms:modified xsi:type="dcterms:W3CDTF">2025-08-27T07:31:53Z</dcterms:modified>
</cp:coreProperties>
</file>